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7" r:id="rId5"/>
    <p:sldId id="264" r:id="rId6"/>
    <p:sldId id="259" r:id="rId7"/>
    <p:sldId id="265" r:id="rId8"/>
    <p:sldId id="261" r:id="rId9"/>
    <p:sldId id="266" r:id="rId10"/>
    <p:sldId id="263" r:id="rId11"/>
    <p:sldId id="26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0"/>
    <p:restoredTop sz="95814"/>
  </p:normalViewPr>
  <p:slideViewPr>
    <p:cSldViewPr snapToGrid="0" snapToObjects="1">
      <p:cViewPr varScale="1">
        <p:scale>
          <a:sx n="120" d="100"/>
          <a:sy n="120" d="100"/>
        </p:scale>
        <p:origin x="114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C0C701-6F4D-F24F-8F07-93AAC30EFE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48BBA0-EB54-F949-A336-64BF7B20A5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4361D8-5915-704E-A291-D4BF136EC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0BB69E-4E50-F540-B495-78409B7D84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A5B3C6-8F64-5F4F-BBFB-DD6A49EEE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299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312AC1-086E-EE4C-96E4-0FF4445A3C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82BBA0-9216-D441-B13C-AF566489A4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3B4FE9-5859-594B-BB56-363F81CFA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100BAC-9434-E449-9609-53145A28A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4AFC02-0162-8347-9827-FEF6F879B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436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15F941-C17A-6F4D-868A-D198D49EC5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8BFBB4-18CA-FB41-8673-3A2CAC261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EF901C-2B88-2C48-949F-C118FEBCBE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72C110-1F76-8045-A6EC-FD2871F2C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8A8A65-1995-6547-9EB0-31CC30E9F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921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9F50E3-3FC9-D04B-9EB7-F8C17687E3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494551-17BF-804C-9BC0-531D0336C6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3ECC4D-BD8C-5F43-A227-BBEA93CD2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AE74EE-B8B7-6B46-BDBA-623A02F695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C09A4F-67F7-A949-A936-7B5D3D78E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24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E175E6-72C5-064C-9645-80EAA15CE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FF574F-070D-3541-BBB8-349862B21A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CCB7EF-DE87-5848-BF32-B4644A2FB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602FC9-C60F-8B46-A0EE-AC3AE0374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56D2DD-4C00-FB45-994A-7E49D22DF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211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B4536-508C-7746-84AD-D84DFD320C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45C6FC-5BF2-504F-8EC6-C2D124665C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020879-2FE8-BB4C-A754-C74048D229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FCD1B4-2980-5945-9617-7349CDB1B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91F341-FDC2-224B-825D-C93455FB0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EB8DFA-8640-4F47-95C1-A6100A28E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914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36EA1-4CE8-AF42-BF7F-44F9C13412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6A8ED1-7CBC-8C48-AE65-B0B098798F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4BAC8C-DC53-914F-A45D-8128F6FE43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3AE03D-8F8B-9D4C-9268-2892AE5BAD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3585E9-2AE2-F348-9C43-C639455E98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234FF7-12EF-B941-8145-858A0FF29E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5783E2-62BC-6447-BB65-3B5559668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652D52-2FF7-E84E-98F1-F02B82FFB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88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625813-4A9D-6B48-B4DB-E47B89A3F0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84BB3E-6416-4E43-A592-3C7F13414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A18EFF-91BC-C141-B846-CFE2A19BA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90E1CF-F91A-B34F-BE26-D1B2CB2BA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969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B8AF8A-770F-344C-8152-4157EA23A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2F0C65-DF25-7042-AABC-A385B595E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8E6886-2068-844A-BA01-5F6E93FEF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414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81C2CE-B9BD-6E4E-BB6C-7F1EAAB01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0FD5CB-040A-7647-BB81-5430726936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3B74D0-E41A-BA40-AA46-9969C60CCA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F9C6CF-9349-9643-8048-6ABBA94185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4CE4D3-59CF-6945-84CF-3B4D1FA75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DA4A26-484D-B74C-9C8D-7D356573B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370764-B7A9-3345-9770-1934BEC073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D0DB3F-CA33-6C43-8F58-CFDE75AACA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5A633F-B1DB-1346-AD95-50098442C7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7E3E06-695C-3D45-8309-60035922E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53E16C-E68F-6A4E-8EB2-AF3BFB0D86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0E71-8828-224D-B768-FC2E65134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87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22787A3-29C8-A04E-ACB1-40FFB745E7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CA8B60-9B1E-BF43-BE0B-B0B096AF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A290DF-4A30-E745-B6E9-796380EBE8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0177AB-C034-9D4B-86C5-47C37B56DD04}" type="datetimeFigureOut">
              <a:rPr lang="en-US" smtClean="0"/>
              <a:t>10/1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F47A35-4829-614A-B294-F458F3AC66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B35D9A-2109-0648-A786-A0FFA52F36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0ADB0E-F863-3641-814A-9E50421D4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323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6.tiff"/><Relationship Id="rId4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1331455"/>
              </p:ext>
            </p:extLst>
          </p:nvPr>
        </p:nvGraphicFramePr>
        <p:xfrm>
          <a:off x="3866116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3114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8961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18053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33954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13468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10101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49858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61175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10101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94198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810418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355113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574790" y="509156"/>
            <a:ext cx="17555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 smtClean="0"/>
              <a:t>Negative </a:t>
            </a:r>
            <a:r>
              <a:rPr lang="en-US" dirty="0"/>
              <a:t>Control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320246" cy="15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415466" y="854328"/>
            <a:ext cx="2241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ys</a:t>
            </a:r>
            <a:r>
              <a:rPr lang="en-US" dirty="0"/>
              <a:t>-less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345805" cy="8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10376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473580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56267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62474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745715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8967591" y="4368282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735119" y="456371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741913" y="521680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8967591" y="3655793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747413" y="387366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8967591" y="5034790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26B1709-C95A-1F4E-A334-D4D4D9F2D6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7006" y="2113775"/>
            <a:ext cx="4419600" cy="38227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2272149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46386-1021-9A45-965A-D8F78A7CF4C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BE0B7D-8381-114E-9D3C-6DD0EBA47928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0562980"/>
              </p:ext>
            </p:extLst>
          </p:nvPr>
        </p:nvGraphicFramePr>
        <p:xfrm>
          <a:off x="3834312" y="1425979"/>
          <a:ext cx="6682746" cy="73677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67291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33955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73711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341907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57808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0215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29370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26004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86247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794516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371016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582744" y="501205"/>
            <a:ext cx="17555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mtClean="0"/>
              <a:t>Negative </a:t>
            </a:r>
            <a:r>
              <a:rPr lang="en-US" dirty="0"/>
              <a:t>Control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320246" cy="15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415466" y="854328"/>
            <a:ext cx="2241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ys</a:t>
            </a:r>
            <a:r>
              <a:rPr lang="en-US" dirty="0"/>
              <a:t>-less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345805" cy="8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415466" y="1143683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473580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56267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62474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745715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8967591" y="4332186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735119" y="452761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741913" y="519253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8967591" y="3655793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747413" y="384186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8967591" y="5002564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DA31899-DCD2-554D-BB91-67D25D3F1C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58813" y="2134652"/>
            <a:ext cx="4483100" cy="36322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375651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1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1245305"/>
              </p:ext>
            </p:extLst>
          </p:nvPr>
        </p:nvGraphicFramePr>
        <p:xfrm>
          <a:off x="3722996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49478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26004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3940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287535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43381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23311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49858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50888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86247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89614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57197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484344" y="501205"/>
            <a:ext cx="22436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No </a:t>
            </a:r>
            <a:r>
              <a:rPr lang="en-US" dirty="0" smtClean="0"/>
              <a:t>Inhibitory Proteins</a:t>
            </a:r>
            <a:endParaRPr lang="en-US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95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A97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57804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79244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721004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902130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98635" y="425696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66163" y="445239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72957" y="520885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98635" y="3655793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978457" y="384186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98635" y="5010937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D833F84-6B1D-C84F-9C13-4E098C5DFA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6936" y="2134652"/>
            <a:ext cx="1130300" cy="3683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8D10BD5-65FE-3544-A948-2F694383FC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97492" y="2134652"/>
            <a:ext cx="1130300" cy="3683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ECDE303-54EA-F047-98D2-4ED9463C41D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647"/>
          <a:stretch/>
        </p:blipFill>
        <p:spPr>
          <a:xfrm>
            <a:off x="6606231" y="2134652"/>
            <a:ext cx="1143000" cy="368478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22C5344-D045-6842-AA01-C32853E378E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886"/>
          <a:stretch/>
        </p:blipFill>
        <p:spPr>
          <a:xfrm>
            <a:off x="7831028" y="2141814"/>
            <a:ext cx="1117600" cy="367583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880071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2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9680273"/>
              </p:ext>
            </p:extLst>
          </p:nvPr>
        </p:nvGraphicFramePr>
        <p:xfrm>
          <a:off x="3730941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27298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33955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35423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47172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13467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81663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86247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420801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476391" y="501205"/>
            <a:ext cx="22436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No </a:t>
            </a:r>
            <a:r>
              <a:rPr lang="en-US" dirty="0" smtClean="0"/>
              <a:t>Inhibitory Proteins</a:t>
            </a:r>
            <a:endParaRPr lang="en-US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95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A97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75057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79244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75709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878065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66198" y="440437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33726" y="459980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40520" y="5300607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66198" y="3764081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946020" y="3950149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66198" y="5142445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24CE647-F081-E549-8935-75A5C6D83FB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010"/>
          <a:stretch/>
        </p:blipFill>
        <p:spPr>
          <a:xfrm>
            <a:off x="4256865" y="2134652"/>
            <a:ext cx="1079500" cy="3683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DD331A0-23EB-E343-BD2C-ACD6018685D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198"/>
          <a:stretch/>
        </p:blipFill>
        <p:spPr>
          <a:xfrm>
            <a:off x="5417040" y="2141814"/>
            <a:ext cx="1117600" cy="36758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665D626-02FB-3740-B246-8E4A7E4250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1489" y="2134652"/>
            <a:ext cx="1104900" cy="3683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79C3610-6948-784D-8979-70CD65A5AE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37678" y="2134652"/>
            <a:ext cx="1079500" cy="3683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400661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1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1848157"/>
              </p:ext>
            </p:extLst>
          </p:nvPr>
        </p:nvGraphicFramePr>
        <p:xfrm>
          <a:off x="3722992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03442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26003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67231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291510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73712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516834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94199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94198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444657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353630" y="501205"/>
            <a:ext cx="24255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 smtClean="0"/>
              <a:t>27BofA + </a:t>
            </a:r>
            <a:r>
              <a:rPr lang="en-US" dirty="0" err="1" smtClean="0"/>
              <a:t>SpoIVFA</a:t>
            </a:r>
            <a:endParaRPr lang="en-US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95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A97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45772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5518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62474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890098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99201" y="4305806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66729" y="450123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73523" y="520203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99201" y="3684265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979023" y="387033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99201" y="5043873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BCD4368-64EF-B546-A0B8-7C3813EAA3C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64"/>
          <a:stretch/>
        </p:blipFill>
        <p:spPr>
          <a:xfrm>
            <a:off x="4234198" y="2134652"/>
            <a:ext cx="1092200" cy="36978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B0F8F24-A89E-684C-943C-4FD817176BF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4"/>
          <a:stretch/>
        </p:blipFill>
        <p:spPr>
          <a:xfrm>
            <a:off x="5391909" y="2157499"/>
            <a:ext cx="1130300" cy="36978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2C070DC-9455-7B41-9E6A-76AD477D8E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13009" y="2158551"/>
            <a:ext cx="1117600" cy="3695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E4C0352-53E2-F845-9458-03E44AA46A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11679" y="2158551"/>
            <a:ext cx="1130300" cy="36957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1468678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2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4552895"/>
              </p:ext>
            </p:extLst>
          </p:nvPr>
        </p:nvGraphicFramePr>
        <p:xfrm>
          <a:off x="3738896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446805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10101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578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48640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10101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4527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26004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02149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500318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353626" y="501205"/>
            <a:ext cx="24255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 smtClean="0"/>
              <a:t>27BofA + </a:t>
            </a:r>
            <a:r>
              <a:rPr lang="en-US" dirty="0" err="1" smtClean="0"/>
              <a:t>SpoIVFA</a:t>
            </a:r>
            <a:endParaRPr lang="en-US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95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A97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626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45772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18968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62474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890098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39372" y="4353275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06900" y="4548704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13694" y="5285716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39372" y="3731734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919194" y="391780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39372" y="5087799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5D817AD-EA0C-C34B-9D3D-32C972005D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9295" y="2134652"/>
            <a:ext cx="1092200" cy="3784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87AA84F-667C-8546-8CB9-FE2F978413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88528" y="2145395"/>
            <a:ext cx="1130300" cy="3784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3FBFE99-60AB-BD44-8F8D-507DF4776C7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650"/>
          <a:stretch/>
        </p:blipFill>
        <p:spPr>
          <a:xfrm>
            <a:off x="6580134" y="2134652"/>
            <a:ext cx="1104900" cy="3784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55EA06C-2DDD-0647-8985-797B56ED18F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715"/>
          <a:stretch/>
        </p:blipFill>
        <p:spPr>
          <a:xfrm>
            <a:off x="7746340" y="2134651"/>
            <a:ext cx="1117600" cy="379534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758931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1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3633426"/>
              </p:ext>
            </p:extLst>
          </p:nvPr>
        </p:nvGraphicFramePr>
        <p:xfrm>
          <a:off x="3746847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3909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0932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33955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270345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588396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73711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92981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49858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62393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444658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763933" y="493254"/>
            <a:ext cx="1620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 err="1" smtClean="0"/>
              <a:t>BofA</a:t>
            </a:r>
            <a:r>
              <a:rPr lang="en-US" dirty="0" smtClean="0"/>
              <a:t> + </a:t>
            </a:r>
            <a:r>
              <a:rPr lang="en-US" dirty="0" err="1" smtClean="0"/>
              <a:t>SpoIVFA</a:t>
            </a:r>
            <a:endParaRPr lang="en-US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95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A97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499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45772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5518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62474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745715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175456" y="4290993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8942984" y="448642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8949778" y="520028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175456" y="3735260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8955278" y="392132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175456" y="5042123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4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E22FC2C-FCB4-7942-A18E-698A1F2EFD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509"/>
          <a:stretch/>
        </p:blipFill>
        <p:spPr>
          <a:xfrm>
            <a:off x="4176479" y="2134652"/>
            <a:ext cx="1143000" cy="36988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76C62F7-D072-7A46-87CD-CFA3ACA08B3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095"/>
          <a:stretch/>
        </p:blipFill>
        <p:spPr>
          <a:xfrm>
            <a:off x="5389071" y="2134652"/>
            <a:ext cx="1130300" cy="36761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E6B523D-76FB-0A46-9399-67E89389C1A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024"/>
          <a:stretch/>
        </p:blipFill>
        <p:spPr>
          <a:xfrm>
            <a:off x="6586203" y="2141814"/>
            <a:ext cx="1117600" cy="36704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6E4A746-D7B0-8A41-B48B-39C554ABB0C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514"/>
          <a:stretch/>
        </p:blipFill>
        <p:spPr>
          <a:xfrm>
            <a:off x="7785348" y="2134652"/>
            <a:ext cx="1092200" cy="367613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481640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9F8BD83-931F-E144-B9DE-7C674F6B90B1}"/>
              </a:ext>
            </a:extLst>
          </p:cNvPr>
          <p:cNvSpPr txBox="1"/>
          <p:nvPr/>
        </p:nvSpPr>
        <p:spPr>
          <a:xfrm>
            <a:off x="632494" y="1172736"/>
            <a:ext cx="7360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et2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25C9830D-339D-2140-B7CD-A7DA8B9FFF6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7799467"/>
              </p:ext>
            </p:extLst>
          </p:nvPr>
        </p:nvGraphicFramePr>
        <p:xfrm>
          <a:off x="3643480" y="1425979"/>
          <a:ext cx="6682746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5185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304589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40912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501173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78436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68208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50032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408058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8501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436695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26004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10100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49243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290945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  <a:gridCol w="346364">
                  <a:extLst>
                    <a:ext uri="{9D8B030D-6E8A-4147-A177-3AD203B41FA5}">
                      <a16:colId xmlns:a16="http://schemas.microsoft.com/office/drawing/2014/main" val="2419459170"/>
                    </a:ext>
                  </a:extLst>
                </a:gridCol>
                <a:gridCol w="863584">
                  <a:extLst>
                    <a:ext uri="{9D8B030D-6E8A-4147-A177-3AD203B41FA5}">
                      <a16:colId xmlns:a16="http://schemas.microsoft.com/office/drawing/2014/main" val="405931063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800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sz="1800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800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1800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DE2251-F7E1-3E42-B923-8EB624AE6126}"/>
              </a:ext>
            </a:extLst>
          </p:cNvPr>
          <p:cNvSpPr/>
          <p:nvPr/>
        </p:nvSpPr>
        <p:spPr>
          <a:xfrm>
            <a:off x="5787786" y="501205"/>
            <a:ext cx="1620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 err="1" smtClean="0"/>
              <a:t>BofA</a:t>
            </a:r>
            <a:r>
              <a:rPr lang="en-US" dirty="0" smtClean="0"/>
              <a:t> + </a:t>
            </a:r>
            <a:r>
              <a:rPr lang="en-US" dirty="0" err="1" smtClean="0"/>
              <a:t>SpoIVFA</a:t>
            </a:r>
            <a:endParaRPr lang="en-US" dirty="0"/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B1C1C5-BFF8-FF4D-8A0E-24B06406C54B}"/>
              </a:ext>
            </a:extLst>
          </p:cNvPr>
          <p:cNvCxnSpPr>
            <a:cxnSpLocks/>
          </p:cNvCxnSpPr>
          <p:nvPr/>
        </p:nvCxnSpPr>
        <p:spPr>
          <a:xfrm>
            <a:off x="4212928" y="883815"/>
            <a:ext cx="47465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B8C9592F-49D7-0844-99C2-8DB7C7D943FF}"/>
              </a:ext>
            </a:extLst>
          </p:cNvPr>
          <p:cNvSpPr txBox="1"/>
          <p:nvPr/>
        </p:nvSpPr>
        <p:spPr>
          <a:xfrm>
            <a:off x="5248722" y="829418"/>
            <a:ext cx="2995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ingle-</a:t>
            </a:r>
            <a:r>
              <a:rPr lang="en-US" dirty="0" err="1"/>
              <a:t>Cys</a:t>
            </a:r>
            <a:r>
              <a:rPr lang="en-US" dirty="0"/>
              <a:t> Pro-</a:t>
            </a:r>
            <a:r>
              <a:rPr lang="en-US" dirty="0" err="1"/>
              <a:t>σ</a:t>
            </a:r>
            <a:r>
              <a:rPr lang="en-US" baseline="30000" dirty="0" err="1"/>
              <a:t>K</a:t>
            </a:r>
            <a:r>
              <a:rPr lang="en-US" dirty="0"/>
              <a:t>(1-127) A97C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737BF3F-6EE7-7A48-85B4-D3C35E84D4BD}"/>
              </a:ext>
            </a:extLst>
          </p:cNvPr>
          <p:cNvCxnSpPr>
            <a:cxnSpLocks/>
          </p:cNvCxnSpPr>
          <p:nvPr/>
        </p:nvCxnSpPr>
        <p:spPr>
          <a:xfrm>
            <a:off x="4187369" y="1153963"/>
            <a:ext cx="47721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DADAD4B-A451-BF44-9398-55F086826971}"/>
              </a:ext>
            </a:extLst>
          </p:cNvPr>
          <p:cNvSpPr txBox="1"/>
          <p:nvPr/>
        </p:nvSpPr>
        <p:spPr>
          <a:xfrm>
            <a:off x="4489403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min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FE3AA2A-12E4-264D-A90B-64D156CF03CF}"/>
              </a:ext>
            </a:extLst>
          </p:cNvPr>
          <p:cNvCxnSpPr>
            <a:cxnSpLocks/>
          </p:cNvCxnSpPr>
          <p:nvPr/>
        </p:nvCxnSpPr>
        <p:spPr>
          <a:xfrm>
            <a:off x="5349970" y="1160379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92A573A-4C4F-D440-AC61-E15E2828EC10}"/>
              </a:ext>
            </a:extLst>
          </p:cNvPr>
          <p:cNvCxnSpPr>
            <a:cxnSpLocks/>
          </p:cNvCxnSpPr>
          <p:nvPr/>
        </p:nvCxnSpPr>
        <p:spPr>
          <a:xfrm>
            <a:off x="6571172" y="1179142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C9ABD0A-8C17-B94D-A3A8-C1A0FC5FA95A}"/>
              </a:ext>
            </a:extLst>
          </p:cNvPr>
          <p:cNvCxnSpPr>
            <a:cxnSpLocks/>
          </p:cNvCxnSpPr>
          <p:nvPr/>
        </p:nvCxnSpPr>
        <p:spPr>
          <a:xfrm>
            <a:off x="7755180" y="1153217"/>
            <a:ext cx="0" cy="9814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4AE5154D-8589-134C-9585-E38585188821}"/>
              </a:ext>
            </a:extLst>
          </p:cNvPr>
          <p:cNvSpPr txBox="1"/>
          <p:nvPr/>
        </p:nvSpPr>
        <p:spPr>
          <a:xfrm>
            <a:off x="5557781" y="114802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0 m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DC14FA-5251-6E41-90A4-35C6A953FEE7}"/>
              </a:ext>
            </a:extLst>
          </p:cNvPr>
          <p:cNvSpPr txBox="1"/>
          <p:nvPr/>
        </p:nvSpPr>
        <p:spPr>
          <a:xfrm>
            <a:off x="6624748" y="1161443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 m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618933-C90E-E54D-8F81-C272538A86F3}"/>
              </a:ext>
            </a:extLst>
          </p:cNvPr>
          <p:cNvSpPr txBox="1"/>
          <p:nvPr/>
        </p:nvSpPr>
        <p:spPr>
          <a:xfrm>
            <a:off x="7745715" y="117273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0 min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CE3BB52-3627-0E44-AE04-A9864AACB996}"/>
              </a:ext>
            </a:extLst>
          </p:cNvPr>
          <p:cNvSpPr/>
          <p:nvPr/>
        </p:nvSpPr>
        <p:spPr>
          <a:xfrm>
            <a:off x="3336940" y="3689370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</a:t>
            </a:r>
            <a:r>
              <a:rPr lang="en-US" dirty="0">
                <a:solidFill>
                  <a:prstClr val="black"/>
                </a:solidFill>
                <a:cs typeface="Arial" panose="020B0604020202020204" pitchFamily="34" charset="0"/>
              </a:rPr>
              <a:t>FLAG</a:t>
            </a:r>
            <a:endParaRPr lang="en-US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EFB319C-01FB-CF45-B370-A688D5811BFC}"/>
              </a:ext>
            </a:extLst>
          </p:cNvPr>
          <p:cNvSpPr txBox="1"/>
          <p:nvPr/>
        </p:nvSpPr>
        <p:spPr>
          <a:xfrm>
            <a:off x="9238956" y="4316393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2D0DA33-455E-C74C-A4FE-3F9B5D705F35}"/>
              </a:ext>
            </a:extLst>
          </p:cNvPr>
          <p:cNvCxnSpPr>
            <a:cxnSpLocks/>
          </p:cNvCxnSpPr>
          <p:nvPr/>
        </p:nvCxnSpPr>
        <p:spPr>
          <a:xfrm flipH="1">
            <a:off x="9006484" y="4511822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C37B689-6B36-1740-81D0-715391613210}"/>
              </a:ext>
            </a:extLst>
          </p:cNvPr>
          <p:cNvCxnSpPr>
            <a:cxnSpLocks/>
          </p:cNvCxnSpPr>
          <p:nvPr/>
        </p:nvCxnSpPr>
        <p:spPr>
          <a:xfrm flipH="1">
            <a:off x="9013278" y="528918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Rectangle 46">
            <a:extLst>
              <a:ext uri="{FF2B5EF4-FFF2-40B4-BE49-F238E27FC236}">
                <a16:creationId xmlns:a16="http://schemas.microsoft.com/office/drawing/2014/main" id="{DB45A5D7-91CB-204C-A340-B265AAA3482A}"/>
              </a:ext>
            </a:extLst>
          </p:cNvPr>
          <p:cNvSpPr/>
          <p:nvPr/>
        </p:nvSpPr>
        <p:spPr>
          <a:xfrm>
            <a:off x="9238956" y="3735260"/>
            <a:ext cx="23628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 dimer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C112A1D-8ADD-B74C-9F34-D182455DA6B6}"/>
              </a:ext>
            </a:extLst>
          </p:cNvPr>
          <p:cNvCxnSpPr>
            <a:cxnSpLocks/>
          </p:cNvCxnSpPr>
          <p:nvPr/>
        </p:nvCxnSpPr>
        <p:spPr>
          <a:xfrm flipH="1">
            <a:off x="9018778" y="392132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ECB1A0D-6AAD-FD49-AEFF-54C7A587AF7B}"/>
              </a:ext>
            </a:extLst>
          </p:cNvPr>
          <p:cNvSpPr txBox="1"/>
          <p:nvPr/>
        </p:nvSpPr>
        <p:spPr>
          <a:xfrm>
            <a:off x="9238956" y="5131023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5E592F-7703-9543-8688-7E0D9A4618EC}"/>
              </a:ext>
            </a:extLst>
          </p:cNvPr>
          <p:cNvSpPr txBox="1"/>
          <p:nvPr/>
        </p:nvSpPr>
        <p:spPr>
          <a:xfrm>
            <a:off x="6789411" y="598275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4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8CC2547-E49E-4148-875D-BB859C397DDA}"/>
              </a:ext>
            </a:extLst>
          </p:cNvPr>
          <p:cNvSpPr txBox="1"/>
          <p:nvPr/>
        </p:nvSpPr>
        <p:spPr>
          <a:xfrm>
            <a:off x="5517216" y="598275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lasmid#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71BD7B6-3752-FF40-BD6B-A2DF670CCAC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290"/>
          <a:stretch/>
        </p:blipFill>
        <p:spPr>
          <a:xfrm>
            <a:off x="4126280" y="2160275"/>
            <a:ext cx="1193800" cy="38131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D05D3E1-047F-3648-B64F-766A4A5317D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313"/>
          <a:stretch/>
        </p:blipFill>
        <p:spPr>
          <a:xfrm>
            <a:off x="5395646" y="2157499"/>
            <a:ext cx="1155700" cy="38121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E45C314-E375-3B4A-AD2E-914E3C084D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15405" y="2141814"/>
            <a:ext cx="1117600" cy="37973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BCC99EB-6FC1-D646-B029-64BDC92A13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03779" y="2141814"/>
            <a:ext cx="1155700" cy="37973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117183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12F5DEF-0062-47F5-9CB9-EC0CB690F24C}">
  <ds:schemaRefs>
    <ds:schemaRef ds:uri="http://schemas.microsoft.com/office/infopath/2007/PartnerControls"/>
    <ds:schemaRef ds:uri="http://purl.org/dc/elements/1.1/"/>
    <ds:schemaRef ds:uri="http://schemas.microsoft.com/office/2006/documentManagement/types"/>
    <ds:schemaRef ds:uri="http://schemas.openxmlformats.org/package/2006/metadata/core-properties"/>
    <ds:schemaRef ds:uri="0b01a07b-8d13-4cb5-9d22-64822278069e"/>
    <ds:schemaRef ds:uri="http://www.w3.org/XML/1998/namespace"/>
    <ds:schemaRef ds:uri="http://purl.org/dc/dcmitype/"/>
    <ds:schemaRef ds:uri="198a9f0d-948e-4f5a-af70-f6d2f30972cd"/>
    <ds:schemaRef ds:uri="http://schemas.microsoft.com/office/2006/metadata/propertie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8D54BA8D-B8D8-4C32-B0DB-92468D0EACF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ABD3D92-E0E5-4B4C-8D61-5FA268CFC30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400</Words>
  <Application>Microsoft Office PowerPoint</Application>
  <PresentationFormat>Widescreen</PresentationFormat>
  <Paragraphs>312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Courier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20</cp:revision>
  <dcterms:created xsi:type="dcterms:W3CDTF">2021-10-05T02:27:35Z</dcterms:created>
  <dcterms:modified xsi:type="dcterms:W3CDTF">2021-10-13T13:21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